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400675" cy="45005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9B90A-A033-4AB6-8D8E-573F18A685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48607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0000" y="2601000"/>
            <a:ext cx="48607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7D4D25-6FED-4AB7-A7CA-69E3334778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76048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0000" y="26010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760480" y="26010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54CDAD-CA2B-4894-BA09-901B53275F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13400" y="10494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557160" y="10494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0000" y="26010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13400" y="26010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557160" y="26010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52C6E-E717-4F52-A24C-CED0F0A7D7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0000" y="1049400"/>
            <a:ext cx="4860720" cy="2970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978E27-AD59-4B58-B1AC-7049DEC6DA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486072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CC196-BB30-4437-8631-F05FD1E885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237168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760480" y="1049400"/>
            <a:ext cx="237168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5D69E-999D-4263-9D02-02DBC1578B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C16CF1-58FA-493C-8C77-6DABA66093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0000" y="180720"/>
            <a:ext cx="4860720" cy="3474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99"/>
              </a:spcBef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88A4E-687E-4932-99D6-916847F06B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760480" y="1049400"/>
            <a:ext cx="237168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0000" y="26010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D47DB-22E1-44D1-B236-F8FC9BB4CE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237168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76048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760480" y="26010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823AEB-DE94-4BAB-976C-B4BB09C4E6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76048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0000" y="2601000"/>
            <a:ext cx="48607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D29F10-B830-4A0B-8BB7-A65004060D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0000" y="1049400"/>
            <a:ext cx="486072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marL="210960" indent="-21096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458640" indent="-17604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2" marL="706320" indent="-14112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3" marL="988920" indent="-14112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4" marL="1271520" indent="-14112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5" marL="1271520" indent="-14112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6" marL="1271520" indent="-14112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69640" y="4172040"/>
            <a:ext cx="1260360" cy="2397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lstStyle>
            <a:lvl1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844640" y="4172040"/>
            <a:ext cx="1711440" cy="2397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870000" y="4172040"/>
            <a:ext cx="1260360" cy="2397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lstStyle>
            <a:lvl1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fld id="{4EC6B033-FBDE-4A20-B78C-020C8EE0EEED}" type="slidenum">
              <a:rPr b="0" lang="en-US" sz="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3"/>
          <p:cNvSpPr/>
          <p:nvPr/>
        </p:nvSpPr>
        <p:spPr>
          <a:xfrm>
            <a:off x="-46080" y="36360"/>
            <a:ext cx="507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dditional table 2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tatistical analysis of organelle densities within caulonemat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4"/>
          <p:cNvSpPr/>
          <p:nvPr/>
        </p:nvSpPr>
        <p:spPr>
          <a:xfrm>
            <a:off x="-44280" y="88884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loroplast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25"/>
          <p:cNvSpPr/>
          <p:nvPr/>
        </p:nvSpPr>
        <p:spPr>
          <a:xfrm>
            <a:off x="1004760" y="426960"/>
            <a:ext cx="134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ip vs. Nucleus are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6"/>
          <p:cNvSpPr/>
          <p:nvPr/>
        </p:nvSpPr>
        <p:spPr>
          <a:xfrm>
            <a:off x="2593800" y="425520"/>
            <a:ext cx="960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ip vs. Bas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7"/>
          <p:cNvSpPr/>
          <p:nvPr/>
        </p:nvSpPr>
        <p:spPr>
          <a:xfrm>
            <a:off x="3816360" y="425520"/>
            <a:ext cx="149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ucleus area vs. Bas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28"/>
          <p:cNvSpPr/>
          <p:nvPr/>
        </p:nvSpPr>
        <p:spPr>
          <a:xfrm>
            <a:off x="-38160" y="119376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eroxisom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29"/>
          <p:cNvSpPr/>
          <p:nvPr/>
        </p:nvSpPr>
        <p:spPr>
          <a:xfrm>
            <a:off x="-30240" y="14986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olg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30"/>
          <p:cNvSpPr/>
          <p:nvPr/>
        </p:nvSpPr>
        <p:spPr>
          <a:xfrm>
            <a:off x="-28440" y="180324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itochondri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31"/>
          <p:cNvSpPr/>
          <p:nvPr/>
        </p:nvSpPr>
        <p:spPr>
          <a:xfrm>
            <a:off x="-28440" y="42696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pical cel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32"/>
          <p:cNvSpPr/>
          <p:nvPr/>
        </p:nvSpPr>
        <p:spPr>
          <a:xfrm>
            <a:off x="-47520" y="276372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loroplast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33"/>
          <p:cNvSpPr/>
          <p:nvPr/>
        </p:nvSpPr>
        <p:spPr>
          <a:xfrm>
            <a:off x="1001880" y="2305080"/>
            <a:ext cx="1344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ip-oriented area vs. Nucleus are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34"/>
          <p:cNvSpPr/>
          <p:nvPr/>
        </p:nvSpPr>
        <p:spPr>
          <a:xfrm>
            <a:off x="2467080" y="2303640"/>
            <a:ext cx="12189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ip-oriented area vs. Bas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35"/>
          <p:cNvSpPr/>
          <p:nvPr/>
        </p:nvSpPr>
        <p:spPr>
          <a:xfrm>
            <a:off x="3813120" y="2303640"/>
            <a:ext cx="149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ucleus area vs. Bas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36"/>
          <p:cNvSpPr/>
          <p:nvPr/>
        </p:nvSpPr>
        <p:spPr>
          <a:xfrm>
            <a:off x="-41400" y="306864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eroxisom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37"/>
          <p:cNvSpPr/>
          <p:nvPr/>
        </p:nvSpPr>
        <p:spPr>
          <a:xfrm>
            <a:off x="-33480" y="337356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olg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38"/>
          <p:cNvSpPr/>
          <p:nvPr/>
        </p:nvSpPr>
        <p:spPr>
          <a:xfrm>
            <a:off x="-31680" y="367812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itochondri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39"/>
          <p:cNvSpPr/>
          <p:nvPr/>
        </p:nvSpPr>
        <p:spPr>
          <a:xfrm>
            <a:off x="-31680" y="23050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b-apical cel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traight Connector 40"/>
          <p:cNvSpPr/>
          <p:nvPr/>
        </p:nvSpPr>
        <p:spPr>
          <a:xfrm>
            <a:off x="27000" y="341280"/>
            <a:ext cx="5329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Straight Connector 41"/>
          <p:cNvSpPr/>
          <p:nvPr/>
        </p:nvSpPr>
        <p:spPr>
          <a:xfrm>
            <a:off x="34920" y="3998880"/>
            <a:ext cx="5327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traight Connector 42"/>
          <p:cNvSpPr/>
          <p:nvPr/>
        </p:nvSpPr>
        <p:spPr>
          <a:xfrm>
            <a:off x="1033560" y="2170080"/>
            <a:ext cx="4321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43"/>
          <p:cNvSpPr/>
          <p:nvPr/>
        </p:nvSpPr>
        <p:spPr>
          <a:xfrm>
            <a:off x="-28440" y="4068720"/>
            <a:ext cx="5441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djusted P values are shown for rejecting equivalence of means by ANOVA; values in bold indicate that the difference is statistically significant at the 0.05 level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44"/>
          <p:cNvSpPr/>
          <p:nvPr/>
        </p:nvSpPr>
        <p:spPr>
          <a:xfrm>
            <a:off x="1042920" y="8938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9306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45"/>
          <p:cNvSpPr/>
          <p:nvPr/>
        </p:nvSpPr>
        <p:spPr>
          <a:xfrm>
            <a:off x="2443320" y="8938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111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46"/>
          <p:cNvSpPr/>
          <p:nvPr/>
        </p:nvSpPr>
        <p:spPr>
          <a:xfrm>
            <a:off x="3932280" y="8920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047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47"/>
          <p:cNvSpPr/>
          <p:nvPr/>
        </p:nvSpPr>
        <p:spPr>
          <a:xfrm>
            <a:off x="1042920" y="27622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858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48"/>
          <p:cNvSpPr/>
          <p:nvPr/>
        </p:nvSpPr>
        <p:spPr>
          <a:xfrm>
            <a:off x="2443320" y="27622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021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49"/>
          <p:cNvSpPr/>
          <p:nvPr/>
        </p:nvSpPr>
        <p:spPr>
          <a:xfrm>
            <a:off x="3932280" y="276084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077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50"/>
          <p:cNvSpPr/>
          <p:nvPr/>
        </p:nvSpPr>
        <p:spPr>
          <a:xfrm>
            <a:off x="1042920" y="367524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6824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51"/>
          <p:cNvSpPr/>
          <p:nvPr/>
        </p:nvSpPr>
        <p:spPr>
          <a:xfrm>
            <a:off x="2443320" y="367524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064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52"/>
          <p:cNvSpPr/>
          <p:nvPr/>
        </p:nvSpPr>
        <p:spPr>
          <a:xfrm>
            <a:off x="3932280" y="367344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343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53"/>
          <p:cNvSpPr/>
          <p:nvPr/>
        </p:nvSpPr>
        <p:spPr>
          <a:xfrm>
            <a:off x="1042920" y="306720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2523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54"/>
          <p:cNvSpPr/>
          <p:nvPr/>
        </p:nvSpPr>
        <p:spPr>
          <a:xfrm>
            <a:off x="2443320" y="306720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295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55"/>
          <p:cNvSpPr/>
          <p:nvPr/>
        </p:nvSpPr>
        <p:spPr>
          <a:xfrm>
            <a:off x="3932280" y="306540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2739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56"/>
          <p:cNvSpPr/>
          <p:nvPr/>
        </p:nvSpPr>
        <p:spPr>
          <a:xfrm>
            <a:off x="1042920" y="119052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17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57"/>
          <p:cNvSpPr/>
          <p:nvPr/>
        </p:nvSpPr>
        <p:spPr>
          <a:xfrm>
            <a:off x="2443320" y="119052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1927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58"/>
          <p:cNvSpPr/>
          <p:nvPr/>
        </p:nvSpPr>
        <p:spPr>
          <a:xfrm>
            <a:off x="3932280" y="11890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024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59"/>
          <p:cNvSpPr/>
          <p:nvPr/>
        </p:nvSpPr>
        <p:spPr>
          <a:xfrm>
            <a:off x="1042920" y="149544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0.000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60"/>
          <p:cNvSpPr/>
          <p:nvPr/>
        </p:nvSpPr>
        <p:spPr>
          <a:xfrm>
            <a:off x="2443320" y="149544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0.000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61"/>
          <p:cNvSpPr/>
          <p:nvPr/>
        </p:nvSpPr>
        <p:spPr>
          <a:xfrm>
            <a:off x="3932280" y="149400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110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62"/>
          <p:cNvSpPr/>
          <p:nvPr/>
        </p:nvSpPr>
        <p:spPr>
          <a:xfrm>
            <a:off x="1042920" y="337176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2997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63"/>
          <p:cNvSpPr/>
          <p:nvPr/>
        </p:nvSpPr>
        <p:spPr>
          <a:xfrm>
            <a:off x="2443320" y="337176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0.000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64"/>
          <p:cNvSpPr/>
          <p:nvPr/>
        </p:nvSpPr>
        <p:spPr>
          <a:xfrm>
            <a:off x="3932280" y="337032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&lt;0.000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65"/>
          <p:cNvSpPr/>
          <p:nvPr/>
        </p:nvSpPr>
        <p:spPr>
          <a:xfrm>
            <a:off x="1041480" y="180972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6550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66"/>
          <p:cNvSpPr/>
          <p:nvPr/>
        </p:nvSpPr>
        <p:spPr>
          <a:xfrm>
            <a:off x="2441520" y="1809720"/>
            <a:ext cx="127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071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67"/>
          <p:cNvSpPr/>
          <p:nvPr/>
        </p:nvSpPr>
        <p:spPr>
          <a:xfrm>
            <a:off x="3930480" y="18082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415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9T00:46:17Z</dcterms:created>
  <dc:creator>fabiennefurt</dc:creator>
  <dc:description/>
  <dc:language>en-US</dc:language>
  <cp:lastModifiedBy>Furt, Fabienne</cp:lastModifiedBy>
  <dcterms:modified xsi:type="dcterms:W3CDTF">2012-02-29T03:17:31Z</dcterms:modified>
  <cp:revision>1</cp:revision>
  <dc:subject/>
  <dc:title>PowerPoint Presentation</dc:title>
</cp:coreProperties>
</file>